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59" r:id="rId2"/>
    <p:sldId id="560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35" userDrawn="1">
          <p15:clr>
            <a:srgbClr val="A4A3A4"/>
          </p15:clr>
        </p15:guide>
        <p15:guide id="2" pos="1141" userDrawn="1">
          <p15:clr>
            <a:srgbClr val="A4A3A4"/>
          </p15:clr>
        </p15:guide>
        <p15:guide id="3" orient="horz" pos="12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22" autoAdjust="0"/>
    <p:restoredTop sz="94660"/>
  </p:normalViewPr>
  <p:slideViewPr>
    <p:cSldViewPr snapToGrid="0">
      <p:cViewPr varScale="1">
        <p:scale>
          <a:sx n="81" d="100"/>
          <a:sy n="81" d="100"/>
        </p:scale>
        <p:origin x="259" y="34"/>
      </p:cViewPr>
      <p:guideLst>
        <p:guide orient="horz" pos="3135"/>
        <p:guide pos="1141"/>
        <p:guide orient="horz" pos="12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E5F22D4-5A97-829B-75FE-CF07B8684B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18575F3D-0FD6-830E-4043-8621CFA998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B1BD560-E5AE-B80B-667C-57D9A2C1D4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C947-3296-4194-9B07-484C56C9C3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2AADE3D-4855-7562-7B71-991E28CCA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13F90AB-60C8-20CE-08FE-F2662E946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B44A-A68F-4A34-8969-F761C4ED339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1693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ED82E40-3A00-370A-3979-49AB6D4D1B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F129A1E-8F7F-95CD-8E90-D8A663DACB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87EF6A9-20CF-2F03-79DE-89411C713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C947-3296-4194-9B07-484C56C9C3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004EB64-499A-C6EC-51DA-BB9A1E712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9481925-7CF2-A08B-36D4-9786D01DC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B44A-A68F-4A34-8969-F761C4ED339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6796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21E87D96-687D-E2B3-4852-AFCF8F7DD1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D1017F8-2513-1FA7-06CF-5CA43AD2BE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6D42941-394B-7080-7E6D-6E04B7DFA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C947-3296-4194-9B07-484C56C9C3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D0A5CD1-787C-8020-D200-139F4D5C9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E63F75B-4BE2-BB3A-539E-9C21F8988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B44A-A68F-4A34-8969-F761C4ED339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164113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89995F5-FDBA-5F14-F821-2D36ED5532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DFA7441-6B0E-E630-44EA-E20587B463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0A1B289-93A7-4EF0-1E4A-B3CCE51A0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C947-3296-4194-9B07-484C56C9C3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5E4FB59-1345-4BAF-F4CF-5395488C2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FB1C7CD-D86F-AA24-2A41-1003EF410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B44A-A68F-4A34-8969-F761C4ED339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2147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EE096D3-178E-4411-0511-F391406A23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F20097F-083B-7578-982A-E9BF729EAB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EA03920-A605-F369-646D-635B9EEA4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C947-3296-4194-9B07-484C56C9C3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88E61BD-E462-08E9-B9E1-D277C1312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6058C7E-8852-1660-2D33-42268D38D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B44A-A68F-4A34-8969-F761C4ED339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78822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23F566-9B94-C807-2436-29BC98F97C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C45960B-9C39-A945-B3A0-3C4B7ED76C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0A1CF50-F74A-4CBC-A8CD-7E3C0E0156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3C9D490-908B-A154-8101-699F83B601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C947-3296-4194-9B07-484C56C9C3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745E305-DC38-7BC2-392D-7B045832B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3C0619D-F4E5-6768-0BA9-F89B9E89CA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B44A-A68F-4A34-8969-F761C4ED339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630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3A8166-CEAC-1C42-AFE4-5C45A516EC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3E22233-5A08-89AF-839D-070808E168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5462FE7-36B5-A3EC-750B-5AAD5595C4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909CB01-A486-EC4D-C4EA-40E26C11B3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8B673E0F-C83B-0CC0-222F-0B4957C181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B4A67720-51F9-43BB-B9BE-8565080F7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C947-3296-4194-9B07-484C56C9C3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0E64F2B-954A-02A9-02F1-EDCB59763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6BF6EE2E-C0FE-9739-6A53-446A49F96F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B44A-A68F-4A34-8969-F761C4ED339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1193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E0EF528-90BE-D2B3-6AFD-DC5067E940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9B9E2CB4-7DDA-AF3D-6049-A3EB8CFD84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C947-3296-4194-9B07-484C56C9C3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FCD721E7-2CBE-8F88-2AF3-0771B666D6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8C3A963D-CDED-DE79-F359-C19EB6F1BB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B44A-A68F-4A34-8969-F761C4ED339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5364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F1D08DE-DE47-7C17-6592-2B16CDE8A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C947-3296-4194-9B07-484C56C9C3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3FF8567A-D424-AF33-6B64-138B0677B8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48E9B3B5-BE12-376F-FA18-442E805ACF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B44A-A68F-4A34-8969-F761C4ED339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178171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2B7E1F3-2E11-A9CC-EB02-841663E7AA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BAB6734-0384-ECCB-C7E4-5DACC54F40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E04398C-3397-216B-5D73-E2E6D88C61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DBBE35C-5F0C-BC66-C72F-5DC80D1118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C947-3296-4194-9B07-484C56C9C3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1C83F12-F244-7712-84F3-CE5C7FADD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C4357A0-E5AC-8440-0B4A-579D25C8B8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B44A-A68F-4A34-8969-F761C4ED339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67023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F9F5858-AC45-C059-0FAE-67CE8522FA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3C76DD2A-C6E9-E674-EF72-12D1732B8A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7FD6360-4F2E-C335-3081-8D7DA57719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5D91142-3C8F-7950-575D-2A5BD5C2D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C947-3296-4194-9B07-484C56C9C3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49017E9-296E-08CF-E00F-444722EBD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558BCDB-5B9F-3423-DED5-7B64B570C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B44A-A68F-4A34-8969-F761C4ED339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9785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4D549F3E-ED3D-CB64-1DAA-D1916F7A55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34473F4-FBC0-6394-BB80-0A74CF7B4E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84A434A-099B-A984-0A2D-D51B7E590C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D5C947-3296-4194-9B07-484C56C9C3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70E6085-6FDF-8A30-8AA6-BA25565EBBC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3CED3B3-5C6D-4132-55F3-2B545C4B88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77B44A-A68F-4A34-8969-F761C4ED339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2536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73F1503-82BD-F145-E1E3-43B106A3B7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5140" y="1778311"/>
            <a:ext cx="4765505" cy="317796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AC38AE0-2138-B8A3-F793-BF1BC42552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22511" y="1778312"/>
            <a:ext cx="4765506" cy="3177961"/>
          </a:xfrm>
          <a:prstGeom prst="rect">
            <a:avLst/>
          </a:prstGeom>
        </p:spPr>
      </p:pic>
      <p:grpSp>
        <p:nvGrpSpPr>
          <p:cNvPr id="16" name="Group 15">
            <a:extLst>
              <a:ext uri="{FF2B5EF4-FFF2-40B4-BE49-F238E27FC236}">
                <a16:creationId xmlns:a16="http://schemas.microsoft.com/office/drawing/2014/main" id="{375A8999-8EF9-1ACF-6FBF-0B2D9A1206B0}"/>
              </a:ext>
            </a:extLst>
          </p:cNvPr>
          <p:cNvGrpSpPr/>
          <p:nvPr/>
        </p:nvGrpSpPr>
        <p:grpSpPr>
          <a:xfrm>
            <a:off x="2495682" y="777711"/>
            <a:ext cx="3663516" cy="1267905"/>
            <a:chOff x="1328387" y="990032"/>
            <a:chExt cx="2996981" cy="813043"/>
          </a:xfrm>
        </p:grpSpPr>
        <p:sp>
          <p:nvSpPr>
            <p:cNvPr id="6" name="CasellaDiTesto 12">
              <a:extLst>
                <a:ext uri="{FF2B5EF4-FFF2-40B4-BE49-F238E27FC236}">
                  <a16:creationId xmlns:a16="http://schemas.microsoft.com/office/drawing/2014/main" id="{57ACEED5-7056-3C83-071B-8FAE896F6BFF}"/>
                </a:ext>
              </a:extLst>
            </p:cNvPr>
            <p:cNvSpPr txBox="1"/>
            <p:nvPr/>
          </p:nvSpPr>
          <p:spPr>
            <a:xfrm>
              <a:off x="1328387" y="1427798"/>
              <a:ext cx="4667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70</a:t>
              </a:r>
            </a:p>
          </p:txBody>
        </p:sp>
        <p:sp>
          <p:nvSpPr>
            <p:cNvPr id="7" name="CasellaDiTesto 13">
              <a:extLst>
                <a:ext uri="{FF2B5EF4-FFF2-40B4-BE49-F238E27FC236}">
                  <a16:creationId xmlns:a16="http://schemas.microsoft.com/office/drawing/2014/main" id="{C2C3DAB9-1D8A-D3C4-3124-14641DD2294A}"/>
                </a:ext>
              </a:extLst>
            </p:cNvPr>
            <p:cNvSpPr txBox="1"/>
            <p:nvPr/>
          </p:nvSpPr>
          <p:spPr>
            <a:xfrm>
              <a:off x="1722138" y="1427798"/>
              <a:ext cx="4667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96</a:t>
              </a:r>
            </a:p>
          </p:txBody>
        </p:sp>
        <p:sp>
          <p:nvSpPr>
            <p:cNvPr id="8" name="CasellaDiTesto 14">
              <a:extLst>
                <a:ext uri="{FF2B5EF4-FFF2-40B4-BE49-F238E27FC236}">
                  <a16:creationId xmlns:a16="http://schemas.microsoft.com/office/drawing/2014/main" id="{B24007B9-A027-BA1A-ED9F-2E4445004A28}"/>
                </a:ext>
              </a:extLst>
            </p:cNvPr>
            <p:cNvSpPr txBox="1"/>
            <p:nvPr/>
          </p:nvSpPr>
          <p:spPr>
            <a:xfrm>
              <a:off x="2117192" y="1427798"/>
              <a:ext cx="5453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134</a:t>
              </a:r>
            </a:p>
          </p:txBody>
        </p:sp>
        <p:sp>
          <p:nvSpPr>
            <p:cNvPr id="9" name="CasellaDiTesto 15">
              <a:extLst>
                <a:ext uri="{FF2B5EF4-FFF2-40B4-BE49-F238E27FC236}">
                  <a16:creationId xmlns:a16="http://schemas.microsoft.com/office/drawing/2014/main" id="{81BDA9BA-282D-38C2-9AC4-2493A9EE09F9}"/>
                </a:ext>
              </a:extLst>
            </p:cNvPr>
            <p:cNvSpPr txBox="1"/>
            <p:nvPr/>
          </p:nvSpPr>
          <p:spPr>
            <a:xfrm>
              <a:off x="2519184" y="1427798"/>
              <a:ext cx="5453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165</a:t>
              </a:r>
            </a:p>
          </p:txBody>
        </p:sp>
        <p:sp>
          <p:nvSpPr>
            <p:cNvPr id="10" name="CasellaDiTesto 16">
              <a:extLst>
                <a:ext uri="{FF2B5EF4-FFF2-40B4-BE49-F238E27FC236}">
                  <a16:creationId xmlns:a16="http://schemas.microsoft.com/office/drawing/2014/main" id="{759DC65A-6812-E2EB-E00F-ACC164267E96}"/>
                </a:ext>
              </a:extLst>
            </p:cNvPr>
            <p:cNvSpPr txBox="1"/>
            <p:nvPr/>
          </p:nvSpPr>
          <p:spPr>
            <a:xfrm>
              <a:off x="2889825" y="1427798"/>
              <a:ext cx="5453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175</a:t>
              </a:r>
            </a:p>
          </p:txBody>
        </p:sp>
        <p:sp>
          <p:nvSpPr>
            <p:cNvPr id="11" name="CasellaDiTesto 17">
              <a:extLst>
                <a:ext uri="{FF2B5EF4-FFF2-40B4-BE49-F238E27FC236}">
                  <a16:creationId xmlns:a16="http://schemas.microsoft.com/office/drawing/2014/main" id="{57E9EF9C-6349-3482-A76F-F8EB7B42F23E}"/>
                </a:ext>
              </a:extLst>
            </p:cNvPr>
            <p:cNvSpPr txBox="1"/>
            <p:nvPr/>
          </p:nvSpPr>
          <p:spPr>
            <a:xfrm rot="5400000">
              <a:off x="3597633" y="1096632"/>
              <a:ext cx="4748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sp>
          <p:nvSpPr>
            <p:cNvPr id="12" name="CasellaDiTesto 18">
              <a:extLst>
                <a:ext uri="{FF2B5EF4-FFF2-40B4-BE49-F238E27FC236}">
                  <a16:creationId xmlns:a16="http://schemas.microsoft.com/office/drawing/2014/main" id="{79A6BB14-9944-0A1D-AE89-D171CF5AAF89}"/>
                </a:ext>
              </a:extLst>
            </p:cNvPr>
            <p:cNvSpPr txBox="1"/>
            <p:nvPr/>
          </p:nvSpPr>
          <p:spPr>
            <a:xfrm rot="5400000">
              <a:off x="3788041" y="1265749"/>
              <a:ext cx="8130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SSU-GFP</a:t>
              </a:r>
            </a:p>
          </p:txBody>
        </p:sp>
        <p:sp>
          <p:nvSpPr>
            <p:cNvPr id="13" name="CasellaDiTesto 16">
              <a:extLst>
                <a:ext uri="{FF2B5EF4-FFF2-40B4-BE49-F238E27FC236}">
                  <a16:creationId xmlns:a16="http://schemas.microsoft.com/office/drawing/2014/main" id="{BF793729-B125-681F-7795-0FC4C1DE39B7}"/>
                </a:ext>
              </a:extLst>
            </p:cNvPr>
            <p:cNvSpPr txBox="1"/>
            <p:nvPr/>
          </p:nvSpPr>
          <p:spPr>
            <a:xfrm rot="5400000">
              <a:off x="3191620" y="1143119"/>
              <a:ext cx="56778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empty</a:t>
              </a:r>
              <a:endParaRPr lang="it-IT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CasellaDiTesto 18">
              <a:extLst>
                <a:ext uri="{FF2B5EF4-FFF2-40B4-BE49-F238E27FC236}">
                  <a16:creationId xmlns:a16="http://schemas.microsoft.com/office/drawing/2014/main" id="{678DEEE3-1A22-77A3-0766-92B94786E85E}"/>
                </a:ext>
              </a:extLst>
            </p:cNvPr>
            <p:cNvSpPr txBox="1"/>
            <p:nvPr/>
          </p:nvSpPr>
          <p:spPr>
            <a:xfrm>
              <a:off x="2136262" y="1215487"/>
              <a:ext cx="5629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RSH3</a:t>
              </a:r>
            </a:p>
          </p:txBody>
        </p:sp>
      </p:grpSp>
      <p:sp>
        <p:nvSpPr>
          <p:cNvPr id="17" name="Rectangle 16">
            <a:extLst>
              <a:ext uri="{FF2B5EF4-FFF2-40B4-BE49-F238E27FC236}">
                <a16:creationId xmlns:a16="http://schemas.microsoft.com/office/drawing/2014/main" id="{C3185515-1CFE-7615-A358-2E02CC723F98}"/>
              </a:ext>
            </a:extLst>
          </p:cNvPr>
          <p:cNvSpPr/>
          <p:nvPr/>
        </p:nvSpPr>
        <p:spPr>
          <a:xfrm>
            <a:off x="2121031" y="3367290"/>
            <a:ext cx="4277609" cy="10161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18A7B7AE-23EA-0A0A-D002-33B3C287B1AC}"/>
              </a:ext>
            </a:extLst>
          </p:cNvPr>
          <p:cNvSpPr/>
          <p:nvPr/>
        </p:nvSpPr>
        <p:spPr>
          <a:xfrm>
            <a:off x="9087439" y="3255739"/>
            <a:ext cx="983530" cy="11277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64C10498-2EC8-CE4B-273B-40C77A988E33}"/>
              </a:ext>
            </a:extLst>
          </p:cNvPr>
          <p:cNvSpPr txBox="1"/>
          <p:nvPr/>
        </p:nvSpPr>
        <p:spPr>
          <a:xfrm>
            <a:off x="9304089" y="5094840"/>
            <a:ext cx="6881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inset</a:t>
            </a:r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asellaDiTesto 7">
            <a:extLst>
              <a:ext uri="{FF2B5EF4-FFF2-40B4-BE49-F238E27FC236}">
                <a16:creationId xmlns:a16="http://schemas.microsoft.com/office/drawing/2014/main" id="{1A529CCE-B718-6472-7EBD-10B7D9B19FE6}"/>
              </a:ext>
            </a:extLst>
          </p:cNvPr>
          <p:cNvSpPr txBox="1"/>
          <p:nvPr/>
        </p:nvSpPr>
        <p:spPr>
          <a:xfrm>
            <a:off x="328670" y="309366"/>
            <a:ext cx="817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nti-GFP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88DD8C2E-6235-801C-9F88-CFAC0EBCB898}"/>
              </a:ext>
            </a:extLst>
          </p:cNvPr>
          <p:cNvGrpSpPr/>
          <p:nvPr/>
        </p:nvGrpSpPr>
        <p:grpSpPr>
          <a:xfrm>
            <a:off x="7594317" y="777711"/>
            <a:ext cx="3663516" cy="1267905"/>
            <a:chOff x="1328387" y="990032"/>
            <a:chExt cx="2996981" cy="813043"/>
          </a:xfrm>
        </p:grpSpPr>
        <p:sp>
          <p:nvSpPr>
            <p:cNvPr id="22" name="CasellaDiTesto 12">
              <a:extLst>
                <a:ext uri="{FF2B5EF4-FFF2-40B4-BE49-F238E27FC236}">
                  <a16:creationId xmlns:a16="http://schemas.microsoft.com/office/drawing/2014/main" id="{3725D7CF-AA80-5AE8-298F-F78900A48539}"/>
                </a:ext>
              </a:extLst>
            </p:cNvPr>
            <p:cNvSpPr txBox="1"/>
            <p:nvPr/>
          </p:nvSpPr>
          <p:spPr>
            <a:xfrm>
              <a:off x="1328387" y="1427798"/>
              <a:ext cx="4667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70</a:t>
              </a:r>
            </a:p>
          </p:txBody>
        </p:sp>
        <p:sp>
          <p:nvSpPr>
            <p:cNvPr id="23" name="CasellaDiTesto 13">
              <a:extLst>
                <a:ext uri="{FF2B5EF4-FFF2-40B4-BE49-F238E27FC236}">
                  <a16:creationId xmlns:a16="http://schemas.microsoft.com/office/drawing/2014/main" id="{66359B07-42D3-5A99-7AD8-7B367463627F}"/>
                </a:ext>
              </a:extLst>
            </p:cNvPr>
            <p:cNvSpPr txBox="1"/>
            <p:nvPr/>
          </p:nvSpPr>
          <p:spPr>
            <a:xfrm>
              <a:off x="1722138" y="1427798"/>
              <a:ext cx="4667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96</a:t>
              </a:r>
            </a:p>
          </p:txBody>
        </p:sp>
        <p:sp>
          <p:nvSpPr>
            <p:cNvPr id="24" name="CasellaDiTesto 14">
              <a:extLst>
                <a:ext uri="{FF2B5EF4-FFF2-40B4-BE49-F238E27FC236}">
                  <a16:creationId xmlns:a16="http://schemas.microsoft.com/office/drawing/2014/main" id="{BAB73CD7-B9B9-211B-984B-45DE1F15CFA9}"/>
                </a:ext>
              </a:extLst>
            </p:cNvPr>
            <p:cNvSpPr txBox="1"/>
            <p:nvPr/>
          </p:nvSpPr>
          <p:spPr>
            <a:xfrm>
              <a:off x="2117192" y="1427798"/>
              <a:ext cx="5453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134</a:t>
              </a:r>
            </a:p>
          </p:txBody>
        </p:sp>
        <p:sp>
          <p:nvSpPr>
            <p:cNvPr id="25" name="CasellaDiTesto 15">
              <a:extLst>
                <a:ext uri="{FF2B5EF4-FFF2-40B4-BE49-F238E27FC236}">
                  <a16:creationId xmlns:a16="http://schemas.microsoft.com/office/drawing/2014/main" id="{559F5712-4950-17D1-5FAD-FCE88B72D1A4}"/>
                </a:ext>
              </a:extLst>
            </p:cNvPr>
            <p:cNvSpPr txBox="1"/>
            <p:nvPr/>
          </p:nvSpPr>
          <p:spPr>
            <a:xfrm>
              <a:off x="2519184" y="1427798"/>
              <a:ext cx="5453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165</a:t>
              </a:r>
            </a:p>
          </p:txBody>
        </p:sp>
        <p:sp>
          <p:nvSpPr>
            <p:cNvPr id="26" name="CasellaDiTesto 16">
              <a:extLst>
                <a:ext uri="{FF2B5EF4-FFF2-40B4-BE49-F238E27FC236}">
                  <a16:creationId xmlns:a16="http://schemas.microsoft.com/office/drawing/2014/main" id="{5AFEB080-F7B5-29B7-CDE2-7E5E2DC7BADE}"/>
                </a:ext>
              </a:extLst>
            </p:cNvPr>
            <p:cNvSpPr txBox="1"/>
            <p:nvPr/>
          </p:nvSpPr>
          <p:spPr>
            <a:xfrm>
              <a:off x="2889825" y="1427798"/>
              <a:ext cx="5453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175</a:t>
              </a:r>
            </a:p>
          </p:txBody>
        </p:sp>
        <p:sp>
          <p:nvSpPr>
            <p:cNvPr id="27" name="CasellaDiTesto 17">
              <a:extLst>
                <a:ext uri="{FF2B5EF4-FFF2-40B4-BE49-F238E27FC236}">
                  <a16:creationId xmlns:a16="http://schemas.microsoft.com/office/drawing/2014/main" id="{9AA2476C-E3C4-A631-4D3F-80C13B7E7E44}"/>
                </a:ext>
              </a:extLst>
            </p:cNvPr>
            <p:cNvSpPr txBox="1"/>
            <p:nvPr/>
          </p:nvSpPr>
          <p:spPr>
            <a:xfrm rot="5400000">
              <a:off x="3597633" y="1096632"/>
              <a:ext cx="4748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sp>
          <p:nvSpPr>
            <p:cNvPr id="28" name="CasellaDiTesto 18">
              <a:extLst>
                <a:ext uri="{FF2B5EF4-FFF2-40B4-BE49-F238E27FC236}">
                  <a16:creationId xmlns:a16="http://schemas.microsoft.com/office/drawing/2014/main" id="{24620652-4E20-C874-B5DD-F191004A9CB0}"/>
                </a:ext>
              </a:extLst>
            </p:cNvPr>
            <p:cNvSpPr txBox="1"/>
            <p:nvPr/>
          </p:nvSpPr>
          <p:spPr>
            <a:xfrm rot="5400000">
              <a:off x="3788041" y="1265749"/>
              <a:ext cx="8130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SSU-GFP</a:t>
              </a:r>
            </a:p>
          </p:txBody>
        </p:sp>
        <p:sp>
          <p:nvSpPr>
            <p:cNvPr id="29" name="CasellaDiTesto 16">
              <a:extLst>
                <a:ext uri="{FF2B5EF4-FFF2-40B4-BE49-F238E27FC236}">
                  <a16:creationId xmlns:a16="http://schemas.microsoft.com/office/drawing/2014/main" id="{E52D02D1-CF31-7D8D-A442-15A05ED73634}"/>
                </a:ext>
              </a:extLst>
            </p:cNvPr>
            <p:cNvSpPr txBox="1"/>
            <p:nvPr/>
          </p:nvSpPr>
          <p:spPr>
            <a:xfrm rot="5400000">
              <a:off x="3191620" y="1143119"/>
              <a:ext cx="56778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empty</a:t>
              </a:r>
              <a:endParaRPr lang="it-IT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CasellaDiTesto 18">
              <a:extLst>
                <a:ext uri="{FF2B5EF4-FFF2-40B4-BE49-F238E27FC236}">
                  <a16:creationId xmlns:a16="http://schemas.microsoft.com/office/drawing/2014/main" id="{91947FCB-A49C-13A4-FDF7-D3872B8ED041}"/>
                </a:ext>
              </a:extLst>
            </p:cNvPr>
            <p:cNvSpPr txBox="1"/>
            <p:nvPr/>
          </p:nvSpPr>
          <p:spPr>
            <a:xfrm>
              <a:off x="2136262" y="1215487"/>
              <a:ext cx="5629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RSH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984111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shower, door, tiled&#10;&#10;Description automatically generated">
            <a:extLst>
              <a:ext uri="{FF2B5EF4-FFF2-40B4-BE49-F238E27FC236}">
                <a16:creationId xmlns:a16="http://schemas.microsoft.com/office/drawing/2014/main" id="{15FDBB9F-7FC9-FC03-0D76-69CEA3766B2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03" r="18691" b="7500"/>
          <a:stretch/>
        </p:blipFill>
        <p:spPr>
          <a:xfrm rot="5400000">
            <a:off x="2314575" y="1218976"/>
            <a:ext cx="4101682" cy="5108156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B77853F8-3545-ACA0-74B7-EF50D2003202}"/>
              </a:ext>
            </a:extLst>
          </p:cNvPr>
          <p:cNvGrpSpPr/>
          <p:nvPr/>
        </p:nvGrpSpPr>
        <p:grpSpPr>
          <a:xfrm>
            <a:off x="2394704" y="777711"/>
            <a:ext cx="3663516" cy="1267905"/>
            <a:chOff x="1328387" y="990032"/>
            <a:chExt cx="2996981" cy="813043"/>
          </a:xfrm>
        </p:grpSpPr>
        <p:sp>
          <p:nvSpPr>
            <p:cNvPr id="5" name="CasellaDiTesto 12">
              <a:extLst>
                <a:ext uri="{FF2B5EF4-FFF2-40B4-BE49-F238E27FC236}">
                  <a16:creationId xmlns:a16="http://schemas.microsoft.com/office/drawing/2014/main" id="{576F7763-B751-6440-775C-EFEC01CF27BF}"/>
                </a:ext>
              </a:extLst>
            </p:cNvPr>
            <p:cNvSpPr txBox="1"/>
            <p:nvPr/>
          </p:nvSpPr>
          <p:spPr>
            <a:xfrm>
              <a:off x="1328387" y="1427798"/>
              <a:ext cx="4667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70</a:t>
              </a:r>
            </a:p>
          </p:txBody>
        </p:sp>
        <p:sp>
          <p:nvSpPr>
            <p:cNvPr id="6" name="CasellaDiTesto 13">
              <a:extLst>
                <a:ext uri="{FF2B5EF4-FFF2-40B4-BE49-F238E27FC236}">
                  <a16:creationId xmlns:a16="http://schemas.microsoft.com/office/drawing/2014/main" id="{05DBDE88-F39F-B3BE-0AF7-F5F7E029E138}"/>
                </a:ext>
              </a:extLst>
            </p:cNvPr>
            <p:cNvSpPr txBox="1"/>
            <p:nvPr/>
          </p:nvSpPr>
          <p:spPr>
            <a:xfrm>
              <a:off x="1722138" y="1427798"/>
              <a:ext cx="4667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96</a:t>
              </a:r>
            </a:p>
          </p:txBody>
        </p:sp>
        <p:sp>
          <p:nvSpPr>
            <p:cNvPr id="7" name="CasellaDiTesto 14">
              <a:extLst>
                <a:ext uri="{FF2B5EF4-FFF2-40B4-BE49-F238E27FC236}">
                  <a16:creationId xmlns:a16="http://schemas.microsoft.com/office/drawing/2014/main" id="{4F0BD8A0-4A8E-A09E-F6B6-50B70085A6B0}"/>
                </a:ext>
              </a:extLst>
            </p:cNvPr>
            <p:cNvSpPr txBox="1"/>
            <p:nvPr/>
          </p:nvSpPr>
          <p:spPr>
            <a:xfrm>
              <a:off x="2117192" y="1427798"/>
              <a:ext cx="5453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134</a:t>
              </a:r>
            </a:p>
          </p:txBody>
        </p:sp>
        <p:sp>
          <p:nvSpPr>
            <p:cNvPr id="8" name="CasellaDiTesto 15">
              <a:extLst>
                <a:ext uri="{FF2B5EF4-FFF2-40B4-BE49-F238E27FC236}">
                  <a16:creationId xmlns:a16="http://schemas.microsoft.com/office/drawing/2014/main" id="{CC0DF75B-3401-59D3-C9CA-85F01B38827E}"/>
                </a:ext>
              </a:extLst>
            </p:cNvPr>
            <p:cNvSpPr txBox="1"/>
            <p:nvPr/>
          </p:nvSpPr>
          <p:spPr>
            <a:xfrm>
              <a:off x="2519184" y="1427798"/>
              <a:ext cx="5453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165</a:t>
              </a:r>
            </a:p>
          </p:txBody>
        </p:sp>
        <p:sp>
          <p:nvSpPr>
            <p:cNvPr id="9" name="CasellaDiTesto 16">
              <a:extLst>
                <a:ext uri="{FF2B5EF4-FFF2-40B4-BE49-F238E27FC236}">
                  <a16:creationId xmlns:a16="http://schemas.microsoft.com/office/drawing/2014/main" id="{331CA8CF-9981-394D-9375-2F3D6DF76A42}"/>
                </a:ext>
              </a:extLst>
            </p:cNvPr>
            <p:cNvSpPr txBox="1"/>
            <p:nvPr/>
          </p:nvSpPr>
          <p:spPr>
            <a:xfrm>
              <a:off x="2889825" y="1427798"/>
              <a:ext cx="5453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1-175</a:t>
              </a:r>
            </a:p>
          </p:txBody>
        </p:sp>
        <p:sp>
          <p:nvSpPr>
            <p:cNvPr id="10" name="CasellaDiTesto 17">
              <a:extLst>
                <a:ext uri="{FF2B5EF4-FFF2-40B4-BE49-F238E27FC236}">
                  <a16:creationId xmlns:a16="http://schemas.microsoft.com/office/drawing/2014/main" id="{03377B67-7C2C-5361-230F-ECF7DC3099D4}"/>
                </a:ext>
              </a:extLst>
            </p:cNvPr>
            <p:cNvSpPr txBox="1"/>
            <p:nvPr/>
          </p:nvSpPr>
          <p:spPr>
            <a:xfrm rot="5400000">
              <a:off x="3597633" y="1096632"/>
              <a:ext cx="4748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sp>
          <p:nvSpPr>
            <p:cNvPr id="11" name="CasellaDiTesto 18">
              <a:extLst>
                <a:ext uri="{FF2B5EF4-FFF2-40B4-BE49-F238E27FC236}">
                  <a16:creationId xmlns:a16="http://schemas.microsoft.com/office/drawing/2014/main" id="{13835B7F-DAA3-0AFD-01FC-EB95B6D2BCBD}"/>
                </a:ext>
              </a:extLst>
            </p:cNvPr>
            <p:cNvSpPr txBox="1"/>
            <p:nvPr/>
          </p:nvSpPr>
          <p:spPr>
            <a:xfrm rot="5400000">
              <a:off x="3788041" y="1265749"/>
              <a:ext cx="8130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SSU-GFP</a:t>
              </a:r>
            </a:p>
          </p:txBody>
        </p:sp>
        <p:sp>
          <p:nvSpPr>
            <p:cNvPr id="12" name="CasellaDiTesto 16">
              <a:extLst>
                <a:ext uri="{FF2B5EF4-FFF2-40B4-BE49-F238E27FC236}">
                  <a16:creationId xmlns:a16="http://schemas.microsoft.com/office/drawing/2014/main" id="{C3A6CA8E-7EBA-6648-13DC-2CBDFFDC6236}"/>
                </a:ext>
              </a:extLst>
            </p:cNvPr>
            <p:cNvSpPr txBox="1"/>
            <p:nvPr/>
          </p:nvSpPr>
          <p:spPr>
            <a:xfrm rot="5400000">
              <a:off x="3191620" y="1143119"/>
              <a:ext cx="56778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empty</a:t>
              </a:r>
              <a:endParaRPr lang="it-IT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CasellaDiTesto 18">
              <a:extLst>
                <a:ext uri="{FF2B5EF4-FFF2-40B4-BE49-F238E27FC236}">
                  <a16:creationId xmlns:a16="http://schemas.microsoft.com/office/drawing/2014/main" id="{B187783C-0386-21A0-E708-5429652E5703}"/>
                </a:ext>
              </a:extLst>
            </p:cNvPr>
            <p:cNvSpPr txBox="1"/>
            <p:nvPr/>
          </p:nvSpPr>
          <p:spPr>
            <a:xfrm>
              <a:off x="2136262" y="1215487"/>
              <a:ext cx="5629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>
                  <a:latin typeface="Arial" panose="020B0604020202020204" pitchFamily="34" charset="0"/>
                  <a:cs typeface="Arial" panose="020B0604020202020204" pitchFamily="34" charset="0"/>
                </a:rPr>
                <a:t>RSH3</a:t>
              </a:r>
            </a:p>
          </p:txBody>
        </p:sp>
      </p:grpSp>
      <p:sp>
        <p:nvSpPr>
          <p:cNvPr id="14" name="Rectangle 13">
            <a:extLst>
              <a:ext uri="{FF2B5EF4-FFF2-40B4-BE49-F238E27FC236}">
                <a16:creationId xmlns:a16="http://schemas.microsoft.com/office/drawing/2014/main" id="{3C3C5056-06BF-0378-EF5F-C74B0A3D9D19}"/>
              </a:ext>
            </a:extLst>
          </p:cNvPr>
          <p:cNvSpPr/>
          <p:nvPr/>
        </p:nvSpPr>
        <p:spPr>
          <a:xfrm>
            <a:off x="2271859" y="2937703"/>
            <a:ext cx="3973399" cy="4912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CasellaDiTesto 7">
            <a:extLst>
              <a:ext uri="{FF2B5EF4-FFF2-40B4-BE49-F238E27FC236}">
                <a16:creationId xmlns:a16="http://schemas.microsoft.com/office/drawing/2014/main" id="{578C0634-4944-557A-4E50-39111A54EDD8}"/>
              </a:ext>
            </a:extLst>
          </p:cNvPr>
          <p:cNvSpPr txBox="1"/>
          <p:nvPr/>
        </p:nvSpPr>
        <p:spPr>
          <a:xfrm>
            <a:off x="328670" y="309366"/>
            <a:ext cx="788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Ponceau</a:t>
            </a:r>
          </a:p>
        </p:txBody>
      </p:sp>
    </p:spTree>
    <p:extLst>
      <p:ext uri="{BB962C8B-B14F-4D97-AF65-F5344CB8AC3E}">
        <p14:creationId xmlns:p14="http://schemas.microsoft.com/office/powerpoint/2010/main" val="1498667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Widescreen</PresentationFormat>
  <Paragraphs>3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tefano D'Alessandro</dc:creator>
  <cp:lastModifiedBy>FIELD Benjamin</cp:lastModifiedBy>
  <cp:revision>2</cp:revision>
  <dcterms:created xsi:type="dcterms:W3CDTF">2022-06-30T09:42:31Z</dcterms:created>
  <dcterms:modified xsi:type="dcterms:W3CDTF">2023-04-13T20:37:09Z</dcterms:modified>
</cp:coreProperties>
</file>